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8" r:id="rId2"/>
    <p:sldId id="257" r:id="rId3"/>
    <p:sldId id="256" r:id="rId4"/>
  </p:sldIdLst>
  <p:sldSz cx="6858000" cy="9907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487"/>
    <p:restoredTop sz="95588"/>
  </p:normalViewPr>
  <p:slideViewPr>
    <p:cSldViewPr snapToGrid="0" snapToObjects="1">
      <p:cViewPr>
        <p:scale>
          <a:sx n="129" d="100"/>
          <a:sy n="129" d="100"/>
        </p:scale>
        <p:origin x="1200" y="-40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451"/>
            <a:ext cx="5829300" cy="3449308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3778"/>
            <a:ext cx="5143500" cy="239204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6CD25B-A707-6C47-A504-0388B7408400}" type="datetimeFigureOut">
              <a:rPr lang="en-US" smtClean="0"/>
              <a:t>2/1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74E1-A985-3044-981D-0F838BC20B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700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6CD25B-A707-6C47-A504-0388B7408400}" type="datetimeFigureOut">
              <a:rPr lang="en-US" smtClean="0"/>
              <a:t>2/1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74E1-A985-3044-981D-0F838BC20B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26065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87"/>
            <a:ext cx="1478756" cy="8396223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87"/>
            <a:ext cx="4350544" cy="8396223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6CD25B-A707-6C47-A504-0388B7408400}" type="datetimeFigureOut">
              <a:rPr lang="en-US" smtClean="0"/>
              <a:t>2/1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74E1-A985-3044-981D-0F838BC20B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50659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6CD25B-A707-6C47-A504-0388B7408400}" type="datetimeFigureOut">
              <a:rPr lang="en-US" smtClean="0"/>
              <a:t>2/1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74E1-A985-3044-981D-0F838BC20B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68926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70019"/>
            <a:ext cx="5915025" cy="4121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30289"/>
            <a:ext cx="5915025" cy="216728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6CD25B-A707-6C47-A504-0388B7408400}" type="datetimeFigureOut">
              <a:rPr lang="en-US" smtClean="0"/>
              <a:t>2/1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74E1-A985-3044-981D-0F838BC20B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4010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436"/>
            <a:ext cx="2914650" cy="628627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436"/>
            <a:ext cx="2914650" cy="628627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6CD25B-A707-6C47-A504-0388B7408400}" type="datetimeFigureOut">
              <a:rPr lang="en-US" smtClean="0"/>
              <a:t>2/17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74E1-A985-3044-981D-0F838BC20B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4202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90"/>
            <a:ext cx="5915025" cy="1915009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736"/>
            <a:ext cx="2901255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9022"/>
            <a:ext cx="2901255" cy="532303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736"/>
            <a:ext cx="2915543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9022"/>
            <a:ext cx="2915543" cy="532303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6CD25B-A707-6C47-A504-0388B7408400}" type="datetimeFigureOut">
              <a:rPr lang="en-US" smtClean="0"/>
              <a:t>2/17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74E1-A985-3044-981D-0F838BC20B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8526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6CD25B-A707-6C47-A504-0388B7408400}" type="datetimeFigureOut">
              <a:rPr lang="en-US" smtClean="0"/>
              <a:t>2/17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74E1-A985-3044-981D-0F838BC20B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92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6CD25B-A707-6C47-A504-0388B7408400}" type="datetimeFigureOut">
              <a:rPr lang="en-US" smtClean="0"/>
              <a:t>2/17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74E1-A985-3044-981D-0F838BC20B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359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511"/>
            <a:ext cx="3471863" cy="704080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6CD25B-A707-6C47-A504-0388B7408400}" type="datetimeFigureOut">
              <a:rPr lang="en-US" smtClean="0"/>
              <a:t>2/17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74E1-A985-3044-981D-0F838BC20B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1191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511"/>
            <a:ext cx="3471863" cy="704080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6CD25B-A707-6C47-A504-0388B7408400}" type="datetimeFigureOut">
              <a:rPr lang="en-US" smtClean="0"/>
              <a:t>2/17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74E1-A985-3044-981D-0F838BC20B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729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90"/>
            <a:ext cx="5915025" cy="19150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436"/>
            <a:ext cx="5915025" cy="62862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6CD25B-A707-6C47-A504-0388B7408400}" type="datetimeFigureOut">
              <a:rPr lang="en-US" smtClean="0"/>
              <a:t>2/1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869"/>
            <a:ext cx="2314575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F574E1-A985-3044-981D-0F838BC20B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19685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C95C519-BFDC-3041-8F6C-7539ACAF9D4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705" t="8787" r="19807" b="29491"/>
          <a:stretch/>
        </p:blipFill>
        <p:spPr>
          <a:xfrm>
            <a:off x="287130" y="2478157"/>
            <a:ext cx="5314122" cy="5989982"/>
          </a:xfrm>
          <a:prstGeom prst="rect">
            <a:avLst/>
          </a:prstGeom>
        </p:spPr>
      </p:pic>
      <p:sp>
        <p:nvSpPr>
          <p:cNvPr id="4" name="Right Brace 3">
            <a:extLst>
              <a:ext uri="{FF2B5EF4-FFF2-40B4-BE49-F238E27FC236}">
                <a16:creationId xmlns:a16="http://schemas.microsoft.com/office/drawing/2014/main" id="{336AFCBC-23E8-0C44-89EB-D57C4306BD2B}"/>
              </a:ext>
            </a:extLst>
          </p:cNvPr>
          <p:cNvSpPr/>
          <p:nvPr/>
        </p:nvSpPr>
        <p:spPr>
          <a:xfrm rot="10800000" flipH="1">
            <a:off x="5601253" y="2642060"/>
            <a:ext cx="250718" cy="3835734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3C7F456-0756-2348-8EC3-D8E11D5A8A1D}"/>
              </a:ext>
            </a:extLst>
          </p:cNvPr>
          <p:cNvSpPr txBox="1"/>
          <p:nvPr/>
        </p:nvSpPr>
        <p:spPr>
          <a:xfrm>
            <a:off x="5833877" y="4367559"/>
            <a:ext cx="6976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/>
              <a:t>α</a:t>
            </a:r>
            <a:endParaRPr lang="en-US" dirty="0"/>
          </a:p>
        </p:txBody>
      </p:sp>
      <p:sp>
        <p:nvSpPr>
          <p:cNvPr id="6" name="Right Brace 5">
            <a:extLst>
              <a:ext uri="{FF2B5EF4-FFF2-40B4-BE49-F238E27FC236}">
                <a16:creationId xmlns:a16="http://schemas.microsoft.com/office/drawing/2014/main" id="{850EE4A0-717D-B648-BFD9-68449A69739C}"/>
              </a:ext>
            </a:extLst>
          </p:cNvPr>
          <p:cNvSpPr/>
          <p:nvPr/>
        </p:nvSpPr>
        <p:spPr>
          <a:xfrm rot="10800000" flipH="1">
            <a:off x="5601252" y="7033591"/>
            <a:ext cx="250719" cy="878751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AE5B7DF-2246-6445-834E-C795F079F7D7}"/>
              </a:ext>
            </a:extLst>
          </p:cNvPr>
          <p:cNvSpPr txBox="1"/>
          <p:nvPr/>
        </p:nvSpPr>
        <p:spPr>
          <a:xfrm>
            <a:off x="5894317" y="7288301"/>
            <a:ext cx="6976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/>
              <a:t>α</a:t>
            </a:r>
            <a:r>
              <a:rPr lang="en-US" dirty="0"/>
              <a:t>’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46B44EC-6EFC-9940-A638-948991FD1C14}"/>
              </a:ext>
            </a:extLst>
          </p:cNvPr>
          <p:cNvSpPr txBox="1"/>
          <p:nvPr/>
        </p:nvSpPr>
        <p:spPr>
          <a:xfrm>
            <a:off x="743212" y="722032"/>
            <a:ext cx="53715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 File 4.A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uctures of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-mycolic acids i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abscessu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ktonic cells, initially reported by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llo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al., 2016  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09903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A21D171-008C-5C4D-98A6-89258F2E42D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516" t="3741" r="20433" b="2072"/>
          <a:stretch/>
        </p:blipFill>
        <p:spPr>
          <a:xfrm rot="16200000">
            <a:off x="2036558" y="480679"/>
            <a:ext cx="2784883" cy="561300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69BD575-3601-6346-AE5D-5FA601D5BADD}"/>
              </a:ext>
            </a:extLst>
          </p:cNvPr>
          <p:cNvSpPr txBox="1"/>
          <p:nvPr/>
        </p:nvSpPr>
        <p:spPr>
          <a:xfrm>
            <a:off x="703385" y="604911"/>
            <a:ext cx="537157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 File 4.B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LDI-TOF graph of wall-bound MAMEs isolates from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abscessu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ktonic cells with accompanying table corresponding to peaks on the graph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 calculated based on previously reported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MA structure by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llo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al., 2016 where in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MA: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lkyl side chain is composed of 13 CH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1 CH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the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hydroxy chain has two double bonds, and 13 CH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1 CH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llowing the distal carbon double bond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Table 5">
            <a:extLst>
              <a:ext uri="{FF2B5EF4-FFF2-40B4-BE49-F238E27FC236}">
                <a16:creationId xmlns:a16="http://schemas.microsoft.com/office/drawing/2014/main" id="{B2E324CE-8D5B-CC4F-9C13-D84A0862F94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2751902"/>
              </p:ext>
            </p:extLst>
          </p:nvPr>
        </p:nvGraphicFramePr>
        <p:xfrm>
          <a:off x="1417320" y="5116354"/>
          <a:ext cx="2117453" cy="2311400"/>
        </p:xfrm>
        <a:graphic>
          <a:graphicData uri="http://schemas.openxmlformats.org/drawingml/2006/table">
            <a:tbl>
              <a:tblPr firstRow="1" bandRow="1">
                <a:tableStyleId>{7E9639D4-E3E2-4D34-9284-5A2195B3D0D7}</a:tableStyleId>
              </a:tblPr>
              <a:tblGrid>
                <a:gridCol w="905256">
                  <a:extLst>
                    <a:ext uri="{9D8B030D-6E8A-4147-A177-3AD203B41FA5}">
                      <a16:colId xmlns:a16="http://schemas.microsoft.com/office/drawing/2014/main" val="34956169"/>
                    </a:ext>
                  </a:extLst>
                </a:gridCol>
                <a:gridCol w="1212197">
                  <a:extLst>
                    <a:ext uri="{9D8B030D-6E8A-4147-A177-3AD203B41FA5}">
                      <a16:colId xmlns:a16="http://schemas.microsoft.com/office/drawing/2014/main" val="299523424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lecular weigh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number of C atom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0236122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18.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9804735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46.2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137707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60.2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425673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74.2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8591098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88.2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10766387"/>
                  </a:ext>
                </a:extLst>
              </a:tr>
            </a:tbl>
          </a:graphicData>
        </a:graphic>
      </p:graphicFrame>
      <p:sp>
        <p:nvSpPr>
          <p:cNvPr id="6" name="Right Brace 5">
            <a:extLst>
              <a:ext uri="{FF2B5EF4-FFF2-40B4-BE49-F238E27FC236}">
                <a16:creationId xmlns:a16="http://schemas.microsoft.com/office/drawing/2014/main" id="{BA914D56-FC39-154C-82D4-C80BD662037B}"/>
              </a:ext>
            </a:extLst>
          </p:cNvPr>
          <p:cNvSpPr/>
          <p:nvPr/>
        </p:nvSpPr>
        <p:spPr>
          <a:xfrm flipH="1">
            <a:off x="1221305" y="5649859"/>
            <a:ext cx="142203" cy="1728216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3D015C3-3E5E-F241-9AE7-E0351368C4F1}"/>
              </a:ext>
            </a:extLst>
          </p:cNvPr>
          <p:cNvSpPr txBox="1"/>
          <p:nvPr/>
        </p:nvSpPr>
        <p:spPr>
          <a:xfrm>
            <a:off x="872496" y="6329301"/>
            <a:ext cx="6976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/>
              <a:t>α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440653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24E8CED-FDBC-7545-AAF6-7F7DD769A95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4353" t="3375" r="20266" b="1782"/>
          <a:stretch/>
        </p:blipFill>
        <p:spPr>
          <a:xfrm rot="16200000">
            <a:off x="2138515" y="354165"/>
            <a:ext cx="2580969" cy="529192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5D45BAE-5F53-CF4E-97E8-D1FF787F8AAF}"/>
              </a:ext>
            </a:extLst>
          </p:cNvPr>
          <p:cNvSpPr txBox="1"/>
          <p:nvPr/>
        </p:nvSpPr>
        <p:spPr>
          <a:xfrm>
            <a:off x="703385" y="604911"/>
            <a:ext cx="578885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 File 4.C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LDI-TOF graph of wall-bound MAMEs isolates from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abscessu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films with accompanying table corresponding to peaks on the graph - calculated based on previously reported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-MA structure by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llo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al., 2016</a:t>
            </a:r>
            <a:endParaRPr lang="en-US" sz="1200" dirty="0"/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Table 5">
            <a:extLst>
              <a:ext uri="{FF2B5EF4-FFF2-40B4-BE49-F238E27FC236}">
                <a16:creationId xmlns:a16="http://schemas.microsoft.com/office/drawing/2014/main" id="{D966F52C-FD21-3046-9496-4359C17038C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07237426"/>
              </p:ext>
            </p:extLst>
          </p:nvPr>
        </p:nvGraphicFramePr>
        <p:xfrm>
          <a:off x="1576833" y="4564342"/>
          <a:ext cx="2439667" cy="3451815"/>
        </p:xfrm>
        <a:graphic>
          <a:graphicData uri="http://schemas.openxmlformats.org/drawingml/2006/table">
            <a:tbl>
              <a:tblPr firstRow="1" bandRow="1">
                <a:tableStyleId>{7E9639D4-E3E2-4D34-9284-5A2195B3D0D7}</a:tableStyleId>
              </a:tblPr>
              <a:tblGrid>
                <a:gridCol w="942334">
                  <a:extLst>
                    <a:ext uri="{9D8B030D-6E8A-4147-A177-3AD203B41FA5}">
                      <a16:colId xmlns:a16="http://schemas.microsoft.com/office/drawing/2014/main" val="34956169"/>
                    </a:ext>
                  </a:extLst>
                </a:gridCol>
                <a:gridCol w="1497333">
                  <a:extLst>
                    <a:ext uri="{9D8B030D-6E8A-4147-A177-3AD203B41FA5}">
                      <a16:colId xmlns:a16="http://schemas.microsoft.com/office/drawing/2014/main" val="2995234241"/>
                    </a:ext>
                  </a:extLst>
                </a:gridCol>
              </a:tblGrid>
              <a:tr h="221521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lecular weigh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carbon atom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02361229"/>
                  </a:ext>
                </a:extLst>
              </a:tr>
              <a:tr h="332735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2.0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98047350"/>
                  </a:ext>
                </a:extLst>
              </a:tr>
              <a:tr h="332735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0.0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13770700"/>
                  </a:ext>
                </a:extLst>
              </a:tr>
              <a:tr h="332735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18.2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42567302"/>
                  </a:ext>
                </a:extLst>
              </a:tr>
              <a:tr h="332735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46.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15054935"/>
                  </a:ext>
                </a:extLst>
              </a:tr>
              <a:tr h="332735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60.2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44817373"/>
                  </a:ext>
                </a:extLst>
              </a:tr>
              <a:tr h="332735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74.2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85910988"/>
                  </a:ext>
                </a:extLst>
              </a:tr>
              <a:tr h="332735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88.3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10766387"/>
                  </a:ext>
                </a:extLst>
              </a:tr>
              <a:tr h="332735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02.3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62091846"/>
                  </a:ext>
                </a:extLst>
              </a:tr>
              <a:tr h="332735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16.3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82387366"/>
                  </a:ext>
                </a:extLst>
              </a:tr>
            </a:tbl>
          </a:graphicData>
        </a:graphic>
      </p:graphicFrame>
      <p:sp>
        <p:nvSpPr>
          <p:cNvPr id="8" name="Right Brace 7">
            <a:extLst>
              <a:ext uri="{FF2B5EF4-FFF2-40B4-BE49-F238E27FC236}">
                <a16:creationId xmlns:a16="http://schemas.microsoft.com/office/drawing/2014/main" id="{71B47F1F-EE05-9B40-901E-79F1798717AD}"/>
              </a:ext>
            </a:extLst>
          </p:cNvPr>
          <p:cNvSpPr/>
          <p:nvPr/>
        </p:nvSpPr>
        <p:spPr>
          <a:xfrm flipH="1">
            <a:off x="1395647" y="5133035"/>
            <a:ext cx="45719" cy="474133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ight Brace 8">
            <a:extLst>
              <a:ext uri="{FF2B5EF4-FFF2-40B4-BE49-F238E27FC236}">
                <a16:creationId xmlns:a16="http://schemas.microsoft.com/office/drawing/2014/main" id="{2F368E7B-DAB2-BF47-B3FE-4354DE5F7E3C}"/>
              </a:ext>
            </a:extLst>
          </p:cNvPr>
          <p:cNvSpPr/>
          <p:nvPr/>
        </p:nvSpPr>
        <p:spPr>
          <a:xfrm flipH="1">
            <a:off x="1395647" y="5724725"/>
            <a:ext cx="45719" cy="2176281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0A69EAA-0738-154F-9824-BE4F92E41D13}"/>
              </a:ext>
            </a:extLst>
          </p:cNvPr>
          <p:cNvSpPr txBox="1"/>
          <p:nvPr/>
        </p:nvSpPr>
        <p:spPr>
          <a:xfrm>
            <a:off x="1083413" y="6619056"/>
            <a:ext cx="6976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/>
              <a:t>α</a:t>
            </a:r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842F89B-EF2B-CE45-B61D-B23E7FEC6543}"/>
              </a:ext>
            </a:extLst>
          </p:cNvPr>
          <p:cNvSpPr txBox="1"/>
          <p:nvPr/>
        </p:nvSpPr>
        <p:spPr>
          <a:xfrm>
            <a:off x="1083413" y="5139078"/>
            <a:ext cx="6976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/>
              <a:t>α</a:t>
            </a:r>
            <a:r>
              <a:rPr lang="en-US" dirty="0"/>
              <a:t>’</a:t>
            </a:r>
          </a:p>
        </p:txBody>
      </p:sp>
    </p:spTree>
    <p:extLst>
      <p:ext uri="{BB962C8B-B14F-4D97-AF65-F5344CB8AC3E}">
        <p14:creationId xmlns:p14="http://schemas.microsoft.com/office/powerpoint/2010/main" val="37182081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3</TotalTime>
  <Words>199</Words>
  <Application>Microsoft Macintosh PowerPoint</Application>
  <PresentationFormat>Custom</PresentationFormat>
  <Paragraphs>4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Anja Dokic (PhD Biosciences FT)</dc:creator>
  <cp:keywords/>
  <dc:description/>
  <cp:lastModifiedBy>Anja Dokic (PhD Biosciences FT)</cp:lastModifiedBy>
  <cp:revision>12</cp:revision>
  <dcterms:created xsi:type="dcterms:W3CDTF">2021-02-14T13:52:17Z</dcterms:created>
  <dcterms:modified xsi:type="dcterms:W3CDTF">2021-02-17T13:29:23Z</dcterms:modified>
  <cp:category/>
</cp:coreProperties>
</file>